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12193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76082C-DCE4-41FE-885A-67B7086532A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B29F3A-992B-4BDB-A877-ED126A8257A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0542B6-E751-48DD-82D3-07EAB8EFDB6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20F865-4AC1-49EF-9F59-22C925BDB9E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BBB00F-7A1B-438F-AA7B-D60603C331D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32106C-BAEC-4710-B28D-A1136E2632F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AC80BF-5463-4133-BEB7-B8DC957825C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FA5DB8-FF02-4BB8-A947-7B3A745B638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D106D5-0762-40A9-ADDC-93BC355BF78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ED0F75-EE75-4ECE-B033-38240BFFFFF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492871-97BA-48F6-99B3-97288501954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03146B-92B0-4D99-A10B-4C689D1A3F0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맑은 고딕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맑은 고딕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맑은 고딕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맑은 고딕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맑은 고딕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맑은 고딕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맑은 고딕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맑은 고딕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맑은 고딕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맑은 고딕"/>
              </a:rPr>
              <a:t>2022-04-06</a:t>
            </a:r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898989"/>
                </a:solidFill>
                <a:latin typeface="맑은 고딕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8E2FE86-17F1-42E3-B03A-7F2E85DC7BB5}" type="slidenum">
              <a:rPr b="0" lang="ko-KR" sz="1200" spc="-1" strike="noStrike">
                <a:solidFill>
                  <a:srgbClr val="898989"/>
                </a:solidFill>
                <a:latin typeface="맑은 고딕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subTitle"/>
          </p:nvPr>
        </p:nvSpPr>
        <p:spPr>
          <a:xfrm>
            <a:off x="119160" y="110880"/>
            <a:ext cx="11958480" cy="7952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맑은 고딕"/>
              </a:rPr>
              <a:t>Supplementary Material 2. Age-standardized prevalence rate of infectious disease by 10 selected groups in Republic of Korea, 2009-2019</a:t>
            </a:r>
            <a:endParaRPr b="0" lang="en-US" sz="2000" spc="-1" strike="noStrike">
              <a:solidFill>
                <a:srgbClr val="000000"/>
              </a:solidFill>
              <a:latin typeface="맑은 고딕"/>
            </a:endParaRPr>
          </a:p>
          <a:p>
            <a:pPr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맑은 고딕"/>
            </a:endParaRPr>
          </a:p>
        </p:txBody>
      </p:sp>
      <p:pic>
        <p:nvPicPr>
          <p:cNvPr id="42" name="그림 3" descr=""/>
          <p:cNvPicPr/>
          <p:nvPr/>
        </p:nvPicPr>
        <p:blipFill>
          <a:blip r:embed="rId1"/>
          <a:stretch/>
        </p:blipFill>
        <p:spPr>
          <a:xfrm>
            <a:off x="1173240" y="1204920"/>
            <a:ext cx="9845640" cy="50641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PlaceHolder 1"/>
          <p:cNvSpPr>
            <a:spLocks noGrp="1"/>
          </p:cNvSpPr>
          <p:nvPr>
            <p:ph type="subTitle"/>
          </p:nvPr>
        </p:nvSpPr>
        <p:spPr>
          <a:xfrm>
            <a:off x="119160" y="110880"/>
            <a:ext cx="11958480" cy="7952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맑은 고딕"/>
              </a:rPr>
              <a:t>(Continued)</a:t>
            </a:r>
            <a:endParaRPr b="0" lang="en-US" sz="2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4" name="부제목 2"/>
          <p:cNvSpPr/>
          <p:nvPr/>
        </p:nvSpPr>
        <p:spPr>
          <a:xfrm>
            <a:off x="119160" y="5635800"/>
            <a:ext cx="11958480" cy="906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 fontScale="95000"/>
          </a:bodyPr>
          <a:p>
            <a:pPr marL="325800" indent="-3258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맑은 고딕"/>
              <a:buAutoNum type="alphaUcParenR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맑은 고딕"/>
              </a:rPr>
              <a:t>Age-standardized prevalence rate associated with respiratory tract infections, intestinal infections, and viral hepatitis </a:t>
            </a:r>
            <a:endParaRPr b="0" lang="en-US" sz="1600" spc="-1" strike="noStrike">
              <a:solidFill>
                <a:srgbClr val="000000"/>
              </a:solidFill>
              <a:latin typeface="맑은 고딕"/>
            </a:endParaRPr>
          </a:p>
          <a:p>
            <a:pPr marL="325800" indent="-3258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맑은 고딕"/>
              <a:buAutoNum type="alphaUcParenR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맑은 고딕"/>
              </a:rPr>
              <a:t>Age-standardizes prevalence rate associated with tuberculosis, sepsis, rheumatic heart diseases, vaccine-preventable diseases, central nervous system infections, HIV-related diseases, and arthropod-borne viral diseases</a:t>
            </a:r>
            <a:endParaRPr b="0" lang="en-US" sz="1600" spc="-1" strike="noStrike">
              <a:solidFill>
                <a:srgbClr val="000000"/>
              </a:solidFill>
              <a:latin typeface="맑은 고딕"/>
            </a:endParaRPr>
          </a:p>
        </p:txBody>
      </p:sp>
      <p:pic>
        <p:nvPicPr>
          <p:cNvPr id="45" name="그림 1" descr=""/>
          <p:cNvPicPr/>
          <p:nvPr/>
        </p:nvPicPr>
        <p:blipFill>
          <a:blip r:embed="rId1"/>
          <a:stretch/>
        </p:blipFill>
        <p:spPr>
          <a:xfrm>
            <a:off x="1262160" y="671400"/>
            <a:ext cx="9536040" cy="47149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1-10-21T11:55:57Z</dcterms:created>
  <dc:creator>mikumiku009@hotmail.com</dc:creator>
  <dc:description/>
  <dc:language>en-US</dc:language>
  <cp:lastModifiedBy>AppPower</cp:lastModifiedBy>
  <dcterms:modified xsi:type="dcterms:W3CDTF">2022-04-26T01:01:39Z</dcterms:modified>
  <cp:revision>5</cp:revision>
  <dc:subject/>
  <dc:title>PowerPoint 프레젠테이션</dc:title>
</cp:coreProperties>
</file>